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8"/>
  </p:notesMasterIdLst>
  <p:sldIdLst>
    <p:sldId id="273" r:id="rId2"/>
    <p:sldId id="274" r:id="rId3"/>
    <p:sldId id="275" r:id="rId4"/>
    <p:sldId id="285" r:id="rId5"/>
    <p:sldId id="278" r:id="rId6"/>
    <p:sldId id="277" r:id="rId7"/>
    <p:sldId id="280" r:id="rId8"/>
    <p:sldId id="286" r:id="rId9"/>
    <p:sldId id="276" r:id="rId10"/>
    <p:sldId id="279" r:id="rId11"/>
    <p:sldId id="281" r:id="rId12"/>
    <p:sldId id="287" r:id="rId13"/>
    <p:sldId id="283" r:id="rId14"/>
    <p:sldId id="282" r:id="rId15"/>
    <p:sldId id="284" r:id="rId16"/>
    <p:sldId id="288" r:id="rId17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FFCCFF"/>
    <a:srgbClr val="A466E8"/>
    <a:srgbClr val="F62402"/>
    <a:srgbClr val="81E1FF"/>
    <a:srgbClr val="64BBFF"/>
    <a:srgbClr val="0066FF"/>
    <a:srgbClr val="FFB1D4"/>
    <a:srgbClr val="B86BE8"/>
    <a:srgbClr val="EA8B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259" autoAdjust="0"/>
    <p:restoredTop sz="94756"/>
  </p:normalViewPr>
  <p:slideViewPr>
    <p:cSldViewPr snapToGrid="0" snapToObjects="1">
      <p:cViewPr varScale="1">
        <p:scale>
          <a:sx n="55" d="100"/>
          <a:sy n="55" d="100"/>
        </p:scale>
        <p:origin x="2196" y="84"/>
      </p:cViewPr>
      <p:guideLst>
        <p:guide orient="horz" pos="2880"/>
        <p:guide pos="2160"/>
      </p:guideLst>
    </p:cSldViewPr>
  </p:slideViewPr>
  <p:notesTextViewPr>
    <p:cViewPr>
      <p:scale>
        <a:sx n="55" d="100"/>
        <a:sy n="55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05255E-8605-3E43-8FE9-7245B3B711D1}" type="datetimeFigureOut">
              <a:rPr lang="en-US" smtClean="0"/>
              <a:t>11/18/20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2CED0B-E5A3-B546-AA01-0C13C12F229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19868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CED0B-E5A3-B546-AA01-0C13C12F2293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9994500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CED0B-E5A3-B546-AA01-0C13C12F2293}" type="slidenum">
              <a:rPr lang="en-US" smtClean="0"/>
              <a:t>1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489535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CED0B-E5A3-B546-AA01-0C13C12F2293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21776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CED0B-E5A3-B546-AA01-0C13C12F2293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6380712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CED0B-E5A3-B546-AA01-0C13C12F2293}" type="slidenum">
              <a:rPr lang="en-US" smtClean="0"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747950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CED0B-E5A3-B546-AA01-0C13C12F2293}" type="slidenum">
              <a:rPr lang="en-US" smtClean="0"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6870264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CED0B-E5A3-B546-AA01-0C13C12F2293}" type="slidenum">
              <a:rPr lang="en-US" smtClean="0"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1955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CED0B-E5A3-B546-AA01-0C13C12F2293}" type="slidenum">
              <a:rPr lang="en-US" smtClean="0"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3040331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CED0B-E5A3-B546-AA01-0C13C12F2293}" type="slidenum">
              <a:rPr lang="en-US" smtClean="0"/>
              <a:t>1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916835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CED0B-E5A3-B546-AA01-0C13C12F2293}" type="slidenum">
              <a:rPr lang="en-US" smtClean="0"/>
              <a:t>1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247096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0C1BB-AA52-B048-B3A3-2E0DCD07DBAA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1250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F8BF6-B504-8544-833C-16673C6A7137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7765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A9E6B-F562-8C4F-BC58-49F5F51DFA96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9231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440D8-65C8-5B40-98CE-EF4E8A9006DF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4540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E7A92-3073-4E4F-BC05-89432EB9E090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73421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EC18D-1ED1-B24D-B21B-EA27D97E7ABC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297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4B051-3829-FE4A-A5A4-DF0FEACD6319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2504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73BD-3B49-B040-B8A8-695B4B571736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2936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5032-A729-7B48-A624-BFE22A8E8458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6928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25F85-7E5D-A14C-9BDE-C26BF4F503C5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13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03E4D-2766-874E-8C73-7B0A6F0AD223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12666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EE3C40-833D-5447-901A-C1C9FF365CAB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149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884997" y="12381"/>
            <a:ext cx="861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A Fig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6519" y="0"/>
            <a:ext cx="4423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1 gene (regulated strain: CAST/EiJ)</a:t>
            </a:r>
          </a:p>
        </p:txBody>
      </p:sp>
      <p:cxnSp>
        <p:nvCxnSpPr>
          <p:cNvPr id="3" name="Straight Arrow Connector 2"/>
          <p:cNvCxnSpPr/>
          <p:nvPr/>
        </p:nvCxnSpPr>
        <p:spPr>
          <a:xfrm flipH="1">
            <a:off x="2706982" y="7668281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400" y="443132"/>
            <a:ext cx="5791200" cy="8686800"/>
          </a:xfrm>
          <a:prstGeom prst="rect">
            <a:avLst/>
          </a:prstGeom>
        </p:spPr>
      </p:pic>
      <p:cxnSp>
        <p:nvCxnSpPr>
          <p:cNvPr id="9" name="Straight Arrow Connector 8"/>
          <p:cNvCxnSpPr/>
          <p:nvPr/>
        </p:nvCxnSpPr>
        <p:spPr>
          <a:xfrm flipH="1">
            <a:off x="3216027" y="7420357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0710121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6519" y="463462"/>
            <a:ext cx="4983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5 gene (regulated strain: PWK/PhJ ;contd)</a:t>
            </a:r>
          </a:p>
        </p:txBody>
      </p:sp>
      <p:pic>
        <p:nvPicPr>
          <p:cNvPr id="9218" name="Picture 2" descr="Z:\dos\waxman-lab\DO\genotype\script\combined_arrays_subset\fig\combined_collage_eqtl\Tff3_eqtl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519" y="1326277"/>
            <a:ext cx="6858000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19" name="Picture 3" descr="Z:\dos\waxman-lab\DO\genotype\script\combined_arrays_subset\fig\combined_collage_eqtl\Tff3_eqtl_chr17_combined_male_coefplot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87" y="2893730"/>
            <a:ext cx="3429000" cy="2743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708660" y="942376"/>
            <a:ext cx="1024456" cy="30508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All Sample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002280" y="942376"/>
            <a:ext cx="1204176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ale Sample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208413" y="948870"/>
            <a:ext cx="1361783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Female Sample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249997" y="0"/>
            <a:ext cx="1567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E Fig (</a:t>
            </a:r>
            <a:r>
              <a:rPr lang="en-US" dirty="0" err="1"/>
              <a:t>contd</a:t>
            </a:r>
            <a:r>
              <a:rPr lang="en-US" dirty="0"/>
              <a:t>)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 flipH="1">
            <a:off x="1414772" y="3476169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flipH="1">
            <a:off x="4250991" y="1894771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47730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6519" y="0"/>
            <a:ext cx="4251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6 gene (regulated strain: WSB/EiJ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834197" y="0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F Fig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528" y="369332"/>
            <a:ext cx="5791200" cy="8686800"/>
          </a:xfrm>
          <a:prstGeom prst="rect">
            <a:avLst/>
          </a:prstGeom>
        </p:spPr>
      </p:pic>
      <p:cxnSp>
        <p:nvCxnSpPr>
          <p:cNvPr id="7" name="Straight Arrow Connector 6"/>
          <p:cNvCxnSpPr/>
          <p:nvPr/>
        </p:nvCxnSpPr>
        <p:spPr>
          <a:xfrm flipH="1">
            <a:off x="4019947" y="7703108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055577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16519" y="512868"/>
            <a:ext cx="4953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6 gene (regulated strain:  WSB/EiJ; contd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08660" y="1021204"/>
            <a:ext cx="1024456" cy="30508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All Sample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002280" y="1021204"/>
            <a:ext cx="1204176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ale Sample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208413" y="1027698"/>
            <a:ext cx="1361783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Female Sample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296547" y="177800"/>
            <a:ext cx="15614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F Fig (contd)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40566"/>
            <a:ext cx="6858000" cy="13716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9" y="3123751"/>
            <a:ext cx="3429000" cy="2743200"/>
          </a:xfrm>
          <a:prstGeom prst="rect">
            <a:avLst/>
          </a:prstGeom>
        </p:spPr>
      </p:pic>
      <p:cxnSp>
        <p:nvCxnSpPr>
          <p:cNvPr id="12" name="Straight Arrow Connector 11"/>
          <p:cNvCxnSpPr/>
          <p:nvPr/>
        </p:nvCxnSpPr>
        <p:spPr>
          <a:xfrm flipH="1">
            <a:off x="3122800" y="4683867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flipH="1">
            <a:off x="3102670" y="1696253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5955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6519" y="0"/>
            <a:ext cx="4423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7 gene (regulated strain: </a:t>
            </a:r>
            <a:r>
              <a:rPr lang="da-DK" dirty="0"/>
              <a:t>C57BL/6J</a:t>
            </a:r>
            <a:r>
              <a:rPr lang="en-US" dirty="0"/>
              <a:t>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821497" y="0"/>
            <a:ext cx="873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G Fig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7045" y="369332"/>
            <a:ext cx="5791200" cy="8686800"/>
          </a:xfrm>
          <a:prstGeom prst="rect">
            <a:avLst/>
          </a:prstGeom>
        </p:spPr>
      </p:pic>
      <p:cxnSp>
        <p:nvCxnSpPr>
          <p:cNvPr id="7" name="Straight Arrow Connector 6"/>
          <p:cNvCxnSpPr/>
          <p:nvPr/>
        </p:nvCxnSpPr>
        <p:spPr>
          <a:xfrm flipH="1">
            <a:off x="1759827" y="7651347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2681954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6519" y="513566"/>
            <a:ext cx="5072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7 gene (regulated strain: </a:t>
            </a:r>
            <a:r>
              <a:rPr lang="da-DK" dirty="0"/>
              <a:t>C57BL/6J</a:t>
            </a:r>
            <a:r>
              <a:rPr lang="en-US" dirty="0"/>
              <a:t>; contd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08660" y="1021204"/>
            <a:ext cx="1024456" cy="30508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All Sample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002280" y="1021204"/>
            <a:ext cx="1204176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ale Sample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208413" y="1027698"/>
            <a:ext cx="1361783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Female Sample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161097" y="127000"/>
            <a:ext cx="1601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G Fig (contd)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9" y="1424860"/>
            <a:ext cx="6858000" cy="13716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701" y="3338422"/>
            <a:ext cx="3429000" cy="2743200"/>
          </a:xfrm>
          <a:prstGeom prst="rect">
            <a:avLst/>
          </a:prstGeom>
        </p:spPr>
      </p:pic>
      <p:cxnSp>
        <p:nvCxnSpPr>
          <p:cNvPr id="12" name="Straight Arrow Connector 11"/>
          <p:cNvCxnSpPr/>
          <p:nvPr/>
        </p:nvCxnSpPr>
        <p:spPr>
          <a:xfrm flipH="1">
            <a:off x="2381844" y="4922284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flipH="1">
            <a:off x="5224767" y="1678994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327845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6519" y="0"/>
            <a:ext cx="4335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8 gene (regulated strain: PWK/PhJ)</a:t>
            </a:r>
          </a:p>
        </p:txBody>
      </p:sp>
      <p:pic>
        <p:nvPicPr>
          <p:cNvPr id="12290" name="Picture 2" descr="Z:\dos\waxman-lab\DO\analysis\fig\expression\test\Gsn_across_datasets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303" y="381713"/>
            <a:ext cx="5791200" cy="868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5783397" y="0"/>
            <a:ext cx="8723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H Fig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 flipH="1">
            <a:off x="3624865" y="6493920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904885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37157" y="525394"/>
            <a:ext cx="49851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8 gene (regulated strain: PWK/PhJ; contd)</a:t>
            </a:r>
          </a:p>
        </p:txBody>
      </p:sp>
      <p:pic>
        <p:nvPicPr>
          <p:cNvPr id="13316" name="Picture 4" descr="Z:\dos\waxman-lab\DO\genotype\script\combined_arrays_subset\fig\combined_collage_eqtl\Gsn_eqtl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298375"/>
            <a:ext cx="6858000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317" name="Picture 5" descr="Z:\dos\waxman-lab\DO\genotype\script\combined_arrays_subset\fig\combined_collage_eqtl\Gsn_eqtl_chr2_combined_female_coefplot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57" y="2841326"/>
            <a:ext cx="3429000" cy="2743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708660" y="942376"/>
            <a:ext cx="1024456" cy="30508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All Sample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002280" y="942376"/>
            <a:ext cx="1204176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ale Sample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208413" y="948870"/>
            <a:ext cx="1361783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Female Sample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084897" y="101600"/>
            <a:ext cx="1599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H Fig (</a:t>
            </a:r>
            <a:r>
              <a:rPr lang="en-US" dirty="0" err="1"/>
              <a:t>contd</a:t>
            </a:r>
            <a:r>
              <a:rPr lang="en-US" dirty="0"/>
              <a:t>)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 flipH="1">
            <a:off x="1095966" y="3550687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flipH="1">
            <a:off x="5020278" y="1645673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907901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9" y="2636219"/>
            <a:ext cx="3429000" cy="27432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86442"/>
            <a:ext cx="6858000" cy="13716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6519" y="338202"/>
            <a:ext cx="5027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1 gene (regulated strain: CAST/EiJ; contd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151212" y="23670"/>
            <a:ext cx="15887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A Fig (contd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08660" y="800488"/>
            <a:ext cx="1024456" cy="30508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All Sample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002280" y="800488"/>
            <a:ext cx="1204176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ale Sample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208413" y="806982"/>
            <a:ext cx="1361783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Female Samples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 flipH="1">
            <a:off x="2787396" y="4219940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flipH="1">
            <a:off x="3931101" y="1509795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019040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789035" y="101281"/>
            <a:ext cx="85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B Fig</a:t>
            </a:r>
          </a:p>
        </p:txBody>
      </p:sp>
      <p:pic>
        <p:nvPicPr>
          <p:cNvPr id="4098" name="Picture 2" descr="Z:\dos\waxman-lab\DO\analysis\fig\expression\test\Sult3a1_across_datasets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2071" y="460736"/>
            <a:ext cx="5791200" cy="868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6519" y="0"/>
            <a:ext cx="4340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2 gene (regulated strain: CAST/EiJ)</a:t>
            </a:r>
          </a:p>
        </p:txBody>
      </p:sp>
      <p:cxnSp>
        <p:nvCxnSpPr>
          <p:cNvPr id="5" name="Straight Arrow Connector 4"/>
          <p:cNvCxnSpPr/>
          <p:nvPr/>
        </p:nvCxnSpPr>
        <p:spPr>
          <a:xfrm flipH="1">
            <a:off x="3202936" y="6879819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385599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151212" y="23670"/>
            <a:ext cx="1580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B Fig (contd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6519" y="487825"/>
            <a:ext cx="492686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2 gene (regulated strain: CAST/EiJ; contd)</a:t>
            </a:r>
          </a:p>
          <a:p>
            <a:endParaRPr lang="en-US" dirty="0"/>
          </a:p>
        </p:txBody>
      </p:sp>
      <p:pic>
        <p:nvPicPr>
          <p:cNvPr id="3077" name="Picture 5" descr="Z:\dos\waxman-lab\DO\genotype\script\combined_arrays_subset\fig\combined_collage_eqtl\Sult3a1_eqtl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3052" y="1475038"/>
            <a:ext cx="6858000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 descr="Z:\dos\waxman-lab\DO\genotype\script\combined_arrays_subset\fig\combined_collage_eqtl\Sult3a1_eqtl_chr10_combined_male_coefplot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766" y="2880505"/>
            <a:ext cx="3429000" cy="2743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708660" y="1071151"/>
            <a:ext cx="1024456" cy="30508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All Sample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002280" y="1071151"/>
            <a:ext cx="1204176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ale Sample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208413" y="1077645"/>
            <a:ext cx="1361783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Female Samples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 flipH="1">
            <a:off x="1606367" y="3738551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flipH="1">
            <a:off x="3668391" y="1921155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050710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00" y="369332"/>
            <a:ext cx="5791200" cy="86868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789035" y="0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C Fig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6519" y="0"/>
            <a:ext cx="44572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3 gene (regulated strain: CAST/EiJ) 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 flipH="1">
            <a:off x="3429000" y="7426084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550997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5745" y="3006390"/>
            <a:ext cx="3429000" cy="27432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5745" y="1369607"/>
            <a:ext cx="6858000" cy="13716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6519" y="375780"/>
            <a:ext cx="4983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3 gene (regulated strain: CAST/EiJ ;contd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773512" y="125270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C Fig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08660" y="942376"/>
            <a:ext cx="1024456" cy="30508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All Sample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002280" y="942376"/>
            <a:ext cx="1204176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ale Sample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208413" y="948870"/>
            <a:ext cx="1361783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Female Samples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 flipH="1">
            <a:off x="2875531" y="3717812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flipH="1">
            <a:off x="6443447" y="1691019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291934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776335" y="0"/>
            <a:ext cx="870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D Fig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6519" y="0"/>
            <a:ext cx="4790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4 gene (regulated strain: 129S1/SvImJ) </a:t>
            </a:r>
          </a:p>
        </p:txBody>
      </p:sp>
      <p:pic>
        <p:nvPicPr>
          <p:cNvPr id="7170" name="Picture 2" descr="Z:\dos\waxman-lab\DO\analysis\fig\expression\test\Cyp2b9_across_datasets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457200"/>
            <a:ext cx="5791200" cy="868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" name="Straight Arrow Connector 4"/>
          <p:cNvCxnSpPr/>
          <p:nvPr/>
        </p:nvCxnSpPr>
        <p:spPr>
          <a:xfrm flipH="1">
            <a:off x="1911312" y="7851105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766019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151212" y="23670"/>
            <a:ext cx="15983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D Fig (contd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6519" y="480403"/>
            <a:ext cx="53240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4 gene (regulated strain: 129S1/SvImJ; contd)</a:t>
            </a:r>
          </a:p>
        </p:txBody>
      </p:sp>
      <p:pic>
        <p:nvPicPr>
          <p:cNvPr id="6148" name="Picture 4" descr="Z:\dos\waxman-lab\DO\genotype\script\combined_arrays_subset\fig\combined_collage_eqtl\Cyp2b9_eqtl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5" y="1327563"/>
            <a:ext cx="6858000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9" name="Picture 5" descr="Z:\dos\waxman-lab\DO\genotype\script\combined_arrays_subset\fig\combined_collage_eqtl\Cyp2b9_eqtl_chr7_combined_female_coefplot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573" y="2713269"/>
            <a:ext cx="3429000" cy="2743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708660" y="942378"/>
            <a:ext cx="1024456" cy="30508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All Sample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002280" y="942378"/>
            <a:ext cx="1204176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ale Sample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208413" y="948872"/>
            <a:ext cx="1361783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Female Samples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 flipH="1">
            <a:off x="1022888" y="4236189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flipH="1">
            <a:off x="5654260" y="1682997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2844449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834197" y="25400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E Fig</a:t>
            </a:r>
          </a:p>
        </p:txBody>
      </p:sp>
      <p:pic>
        <p:nvPicPr>
          <p:cNvPr id="8194" name="Picture 2" descr="Z:\dos\waxman-lab\DO\analysis\fig\expression\test\Tff3_across_datasets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602" y="451552"/>
            <a:ext cx="5791200" cy="868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6519" y="0"/>
            <a:ext cx="43344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5 gene (regulated strain: PWK/PhJ)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3540454" y="6670625"/>
            <a:ext cx="126749" cy="19012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262477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90</TotalTime>
  <Words>303</Words>
  <Application>Microsoft Office PowerPoint</Application>
  <PresentationFormat>On-screen Show (4:3)</PresentationFormat>
  <Paragraphs>66</Paragraphs>
  <Slides>16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ia, Tisha</dc:creator>
  <cp:lastModifiedBy>sathiya vikram</cp:lastModifiedBy>
  <cp:revision>360</cp:revision>
  <cp:lastPrinted>2017-11-21T17:42:59Z</cp:lastPrinted>
  <dcterms:created xsi:type="dcterms:W3CDTF">2017-09-02T16:40:31Z</dcterms:created>
  <dcterms:modified xsi:type="dcterms:W3CDTF">2020-11-18T08:06:57Z</dcterms:modified>
</cp:coreProperties>
</file>